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9"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1"/>
    <p:restoredTop sz="96327"/>
  </p:normalViewPr>
  <p:slideViewPr>
    <p:cSldViewPr snapToGrid="0" snapToObjects="1">
      <p:cViewPr varScale="1">
        <p:scale>
          <a:sx n="128" d="100"/>
          <a:sy n="128" d="100"/>
        </p:scale>
        <p:origin x="480"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326E60-5CAB-0D4F-9832-C60D3337B1C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B37482F-3BBE-7246-A89B-C4E86CA1A95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9B3AD81-DED5-6A41-B5EA-C7B23BBB9618}"/>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CF6B94E8-E494-B64C-B60F-774A20D4B93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524A57-B3C2-C546-88D5-B8567C3A29B4}"/>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7319330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227A9F-4896-D242-AB9F-E6120A05FD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E3EB960-A808-DA47-BB09-782BADBDCDB3}"/>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89E881-7BA4-3746-947C-94CEEA6F2B1C}"/>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6EE454E2-6298-044F-9DAE-44CAAC00409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CCD1289-15F1-3545-B5D4-E09ACAEC83FD}"/>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42472904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BF627E69-0A26-EE4B-80CD-3297D5B3F5A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A9E584E-C618-CA4C-9437-C6634F4B48C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B698AE-97D9-854F-8858-6DF7ADE86B6F}"/>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4437143B-1776-2B46-BB2A-671C68B7CD7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A9010AA-FB7A-D346-A5FA-047E7F889961}"/>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489170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574E9B9-1295-1746-9FCD-C23C4495DC1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CD58457-2689-4F47-8B36-F975C6E4D84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04B4CA3-6527-7848-87DD-D18EF8364B8F}"/>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4B3F6AE6-2A3D-5043-8060-50A950F0747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A016FA2-C4BC-B342-8D5C-FFE222366826}"/>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7946710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B14DD6F-8EDA-8042-AB96-828D7AC6CD3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33579D5-EB8D-4C45-878C-760E97FB690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B08ECE0-C019-8246-A182-5A07AA607CA6}"/>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D0286E5E-60A6-124C-88A3-2A057E406F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FF7E4C3-ACE0-354F-88A8-A300100C0A46}"/>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211643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D1B5EF-D02F-2C4A-B4CE-D4FD3C00B23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A1787A2-AE6C-504E-ADC0-4B3066B553F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DE0566C-D1ED-6E44-800A-0866E67C602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9B8A3FD-64AE-5A44-82F6-CA0DA91F51D4}"/>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B95468D5-0944-7F43-8C54-E7D5D50C6D4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AE007E4-8EC8-784B-A72A-6D1FA3C2B044}"/>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41494005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BC7E22-C2D8-8B49-AE4C-99B0AEE4489B}"/>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9899BED-BA33-E346-B890-6D2EF1066F0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C971F25-DBC7-5E4B-AA86-1C6048C5536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2B03575-416E-884E-A6DE-9F73AF25E4E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D373D1-C5BD-A340-85E4-26F21F7295D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2CAC8E6-C8D0-F948-9DDF-A28EC427D4C3}"/>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8" name="Footer Placeholder 7">
            <a:extLst>
              <a:ext uri="{FF2B5EF4-FFF2-40B4-BE49-F238E27FC236}">
                <a16:creationId xmlns:a16="http://schemas.microsoft.com/office/drawing/2014/main" id="{F05CB6F7-AA69-6741-BA8F-D43D612320B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747E9CE-8241-CF44-AB5E-B226BAB4FFE1}"/>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29123136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9C3334-87A8-7044-A7BB-ABACB2E587D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DF95BA3-0909-C047-B996-7F590EEA76A4}"/>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4" name="Footer Placeholder 3">
            <a:extLst>
              <a:ext uri="{FF2B5EF4-FFF2-40B4-BE49-F238E27FC236}">
                <a16:creationId xmlns:a16="http://schemas.microsoft.com/office/drawing/2014/main" id="{D46A5869-4578-6847-830A-DCDA04573C0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802F8E7-C7D2-F540-8616-349CCD46A6AB}"/>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19489859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6DF2A93-005A-9046-87C8-AE2A18D1E602}"/>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3" name="Footer Placeholder 2">
            <a:extLst>
              <a:ext uri="{FF2B5EF4-FFF2-40B4-BE49-F238E27FC236}">
                <a16:creationId xmlns:a16="http://schemas.microsoft.com/office/drawing/2014/main" id="{358916BD-5718-1942-910F-7721B3E7612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DE4A17F-5CB0-044C-AD94-ADFDC163B68A}"/>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9225505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133C1C-795D-1142-8A23-3531C8B37CE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BF17CC3-AC98-3D4B-BB85-3CEACE3801D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3BC4DD-AD10-4B45-90B5-10D76B13288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44CB674-A5F5-774D-8AEB-754B12FB6E4B}"/>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B056B79E-EBD0-934C-AA19-A01555FC65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FB28945-64C6-614C-B5E2-A6F863A07A5B}"/>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22861620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4CAC08-01C0-D34E-90DE-D62ABD5F291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5DF0F56-91A8-9344-BE6C-51D5C708DA5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A060D65-935E-2849-8065-68A029CF750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2EA5F0-9F57-3B43-B1F0-3A16BAF02222}"/>
              </a:ext>
            </a:extLst>
          </p:cNvPr>
          <p:cNvSpPr>
            <a:spLocks noGrp="1"/>
          </p:cNvSpPr>
          <p:nvPr>
            <p:ph type="dt" sz="half" idx="10"/>
          </p:nvPr>
        </p:nvSpPr>
        <p:spPr/>
        <p:txBody>
          <a:bodyPr/>
          <a:lstStyle/>
          <a:p>
            <a:fld id="{63915683-30F4-2D48-91DD-E35CB51A9DF1}" type="datetimeFigureOut">
              <a:rPr lang="en-US" smtClean="0"/>
              <a:t>3/7/22</a:t>
            </a:fld>
            <a:endParaRPr lang="en-US"/>
          </a:p>
        </p:txBody>
      </p:sp>
      <p:sp>
        <p:nvSpPr>
          <p:cNvPr id="6" name="Footer Placeholder 5">
            <a:extLst>
              <a:ext uri="{FF2B5EF4-FFF2-40B4-BE49-F238E27FC236}">
                <a16:creationId xmlns:a16="http://schemas.microsoft.com/office/drawing/2014/main" id="{3C15758C-BC69-B34E-B00B-5844C874611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E8AC13C-3EE9-9242-9A44-5DB75A4CD10F}"/>
              </a:ext>
            </a:extLst>
          </p:cNvPr>
          <p:cNvSpPr>
            <a:spLocks noGrp="1"/>
          </p:cNvSpPr>
          <p:nvPr>
            <p:ph type="sldNum" sz="quarter" idx="12"/>
          </p:nvPr>
        </p:nvSpPr>
        <p:spPr/>
        <p:txBody>
          <a:bodyPr/>
          <a:lstStyle/>
          <a:p>
            <a:fld id="{783F5DCA-6D21-8740-9F65-58CEFC1F120F}" type="slidenum">
              <a:rPr lang="en-US" smtClean="0"/>
              <a:t>‹#›</a:t>
            </a:fld>
            <a:endParaRPr lang="en-US"/>
          </a:p>
        </p:txBody>
      </p:sp>
    </p:spTree>
    <p:extLst>
      <p:ext uri="{BB962C8B-B14F-4D97-AF65-F5344CB8AC3E}">
        <p14:creationId xmlns:p14="http://schemas.microsoft.com/office/powerpoint/2010/main" val="362271124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17BB337-A069-BA42-9D4B-04B1D5CB92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0B6F025-FD78-1F42-AEC2-38DCF1EE8A4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83A7C90-DD23-7F4C-9E12-98E0D073DCA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3915683-30F4-2D48-91DD-E35CB51A9DF1}" type="datetimeFigureOut">
              <a:rPr lang="en-US" smtClean="0"/>
              <a:t>3/7/22</a:t>
            </a:fld>
            <a:endParaRPr lang="en-US"/>
          </a:p>
        </p:txBody>
      </p:sp>
      <p:sp>
        <p:nvSpPr>
          <p:cNvPr id="5" name="Footer Placeholder 4">
            <a:extLst>
              <a:ext uri="{FF2B5EF4-FFF2-40B4-BE49-F238E27FC236}">
                <a16:creationId xmlns:a16="http://schemas.microsoft.com/office/drawing/2014/main" id="{7A87A7A9-E4A8-6F44-AB7A-6B3F41CCC3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870DF944-A46F-0441-BE12-2370D1B98DE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83F5DCA-6D21-8740-9F65-58CEFC1F120F}" type="slidenum">
              <a:rPr lang="en-US" smtClean="0"/>
              <a:t>‹#›</a:t>
            </a:fld>
            <a:endParaRPr lang="en-US"/>
          </a:p>
        </p:txBody>
      </p:sp>
    </p:spTree>
    <p:extLst>
      <p:ext uri="{BB962C8B-B14F-4D97-AF65-F5344CB8AC3E}">
        <p14:creationId xmlns:p14="http://schemas.microsoft.com/office/powerpoint/2010/main" val="37975271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CFC9F359-0BE1-2743-8274-A40CE4AE896B}"/>
              </a:ext>
            </a:extLst>
          </p:cNvPr>
          <p:cNvPicPr>
            <a:picLocks noChangeAspect="1"/>
          </p:cNvPicPr>
          <p:nvPr/>
        </p:nvPicPr>
        <p:blipFill>
          <a:blip r:embed="rId2"/>
          <a:stretch>
            <a:fillRect/>
          </a:stretch>
        </p:blipFill>
        <p:spPr>
          <a:xfrm>
            <a:off x="1996313" y="219572"/>
            <a:ext cx="8199373" cy="4873083"/>
          </a:xfrm>
          <a:prstGeom prst="rect">
            <a:avLst/>
          </a:prstGeom>
        </p:spPr>
      </p:pic>
      <p:sp>
        <p:nvSpPr>
          <p:cNvPr id="3" name="TextBox 2">
            <a:extLst>
              <a:ext uri="{FF2B5EF4-FFF2-40B4-BE49-F238E27FC236}">
                <a16:creationId xmlns:a16="http://schemas.microsoft.com/office/drawing/2014/main" id="{B078F0E5-EB6C-AC41-80EF-0B18B8E118F3}"/>
              </a:ext>
            </a:extLst>
          </p:cNvPr>
          <p:cNvSpPr txBox="1"/>
          <p:nvPr/>
        </p:nvSpPr>
        <p:spPr>
          <a:xfrm>
            <a:off x="2007199" y="5204621"/>
            <a:ext cx="8199373" cy="1831271"/>
          </a:xfrm>
          <a:prstGeom prst="rect">
            <a:avLst/>
          </a:prstGeom>
          <a:noFill/>
        </p:spPr>
        <p:txBody>
          <a:bodyPr wrap="square" rtlCol="0">
            <a:spAutoFit/>
          </a:bodyPr>
          <a:lstStyle/>
          <a:p>
            <a:pPr algn="just"/>
            <a:r>
              <a:rPr lang="en-US" sz="1300" b="1" dirty="0"/>
              <a:t>Supplementary Figure 3.</a:t>
            </a:r>
            <a:r>
              <a:rPr lang="en-US" sz="1300" dirty="0"/>
              <a:t> Scatterplots of DNAmFitAge versus age in training and test datasets separated by sex. Pink indicates females, and blue indicates males. Each panel corresponds to the performance of DNAmFitAge across datasets displayed with Pearson correlation to chronological age and corresponding p-values.</a:t>
            </a:r>
            <a:r>
              <a:rPr lang="en-US" sz="1300" b="1" dirty="0"/>
              <a:t> (A) </a:t>
            </a:r>
            <a:r>
              <a:rPr lang="en-US" sz="1300" dirty="0"/>
              <a:t>DNAmFitAge performance in training dataset built in each sex separately. (</a:t>
            </a:r>
            <a:r>
              <a:rPr lang="en-US" sz="1300" b="1" dirty="0"/>
              <a:t>B-H) </a:t>
            </a:r>
            <a:r>
              <a:rPr lang="en-US" sz="1300" dirty="0"/>
              <a:t>DNAmFitAge models applied to the opposite sex it was built in (ie DNAmFitAge built for females tested in males and DNAmFitAge built for males tested in females). Females are estimated to be older than they are, and males are estimated to be younger than they are in training and test datasets. </a:t>
            </a:r>
          </a:p>
          <a:p>
            <a:endParaRPr lang="en-US" sz="1100" dirty="0"/>
          </a:p>
          <a:p>
            <a:endParaRPr lang="en-US" sz="1100" dirty="0"/>
          </a:p>
        </p:txBody>
      </p:sp>
    </p:spTree>
    <p:extLst>
      <p:ext uri="{BB962C8B-B14F-4D97-AF65-F5344CB8AC3E}">
        <p14:creationId xmlns:p14="http://schemas.microsoft.com/office/powerpoint/2010/main" val="350781408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120</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1</vt:i4>
      </vt:variant>
      <vt:variant>
        <vt:lpstr>Theme</vt:lpstr>
      </vt:variant>
      <vt:variant>
        <vt:i4>1</vt:i4>
      </vt:variant>
      <vt:variant>
        <vt:lpstr>Slide Titles</vt:lpstr>
      </vt:variant>
      <vt:variant>
        <vt:i4>1</vt:i4>
      </vt:variant>
    </vt:vector>
  </HeadingPairs>
  <TitlesOfParts>
    <vt:vector size="3" baseType="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risten McGreevy</dc:creator>
  <cp:lastModifiedBy>Kristen McGreevy</cp:lastModifiedBy>
  <cp:revision>3</cp:revision>
  <dcterms:created xsi:type="dcterms:W3CDTF">2022-03-08T00:08:06Z</dcterms:created>
  <dcterms:modified xsi:type="dcterms:W3CDTF">2022-03-08T00:09:38Z</dcterms:modified>
</cp:coreProperties>
</file>